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9933"/>
    <a:srgbClr val="FF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779" autoAdjust="0"/>
    <p:restoredTop sz="94660"/>
  </p:normalViewPr>
  <p:slideViewPr>
    <p:cSldViewPr snapToGrid="0">
      <p:cViewPr varScale="1">
        <p:scale>
          <a:sx n="71" d="100"/>
          <a:sy n="71" d="100"/>
        </p:scale>
        <p:origin x="103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EF97-FD35-483A-9D87-18A19C17ED98}" type="datetimeFigureOut">
              <a:rPr lang="en-US" smtClean="0"/>
              <a:t>8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705B2-13DF-4A27-9C13-2CF291794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1042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EF97-FD35-483A-9D87-18A19C17ED98}" type="datetimeFigureOut">
              <a:rPr lang="en-US" smtClean="0"/>
              <a:t>8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705B2-13DF-4A27-9C13-2CF291794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48976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EF97-FD35-483A-9D87-18A19C17ED98}" type="datetimeFigureOut">
              <a:rPr lang="en-US" smtClean="0"/>
              <a:t>8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705B2-13DF-4A27-9C13-2CF291794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8423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EF97-FD35-483A-9D87-18A19C17ED98}" type="datetimeFigureOut">
              <a:rPr lang="en-US" smtClean="0"/>
              <a:t>8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705B2-13DF-4A27-9C13-2CF291794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221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EF97-FD35-483A-9D87-18A19C17ED98}" type="datetimeFigureOut">
              <a:rPr lang="en-US" smtClean="0"/>
              <a:t>8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705B2-13DF-4A27-9C13-2CF291794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264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EF97-FD35-483A-9D87-18A19C17ED98}" type="datetimeFigureOut">
              <a:rPr lang="en-US" smtClean="0"/>
              <a:t>8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705B2-13DF-4A27-9C13-2CF291794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5045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EF97-FD35-483A-9D87-18A19C17ED98}" type="datetimeFigureOut">
              <a:rPr lang="en-US" smtClean="0"/>
              <a:t>8/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705B2-13DF-4A27-9C13-2CF291794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0618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EF97-FD35-483A-9D87-18A19C17ED98}" type="datetimeFigureOut">
              <a:rPr lang="en-US" smtClean="0"/>
              <a:t>8/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705B2-13DF-4A27-9C13-2CF291794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0890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EF97-FD35-483A-9D87-18A19C17ED98}" type="datetimeFigureOut">
              <a:rPr lang="en-US" smtClean="0"/>
              <a:t>8/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705B2-13DF-4A27-9C13-2CF291794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7076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EF97-FD35-483A-9D87-18A19C17ED98}" type="datetimeFigureOut">
              <a:rPr lang="en-US" smtClean="0"/>
              <a:t>8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705B2-13DF-4A27-9C13-2CF291794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6181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2EF97-FD35-483A-9D87-18A19C17ED98}" type="datetimeFigureOut">
              <a:rPr lang="en-US" smtClean="0"/>
              <a:t>8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4705B2-13DF-4A27-9C13-2CF291794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665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42EF97-FD35-483A-9D87-18A19C17ED98}" type="datetimeFigureOut">
              <a:rPr lang="en-US" smtClean="0"/>
              <a:t>8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4705B2-13DF-4A27-9C13-2CF291794E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53137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/>
          <p:cNvGrpSpPr/>
          <p:nvPr/>
        </p:nvGrpSpPr>
        <p:grpSpPr>
          <a:xfrm>
            <a:off x="1803398" y="1358855"/>
            <a:ext cx="8520265" cy="3922143"/>
            <a:chOff x="1816845" y="1735373"/>
            <a:chExt cx="8520265" cy="3922143"/>
          </a:xfrm>
        </p:grpSpPr>
        <p:grpSp>
          <p:nvGrpSpPr>
            <p:cNvPr id="16" name="Group 15"/>
            <p:cNvGrpSpPr/>
            <p:nvPr/>
          </p:nvGrpSpPr>
          <p:grpSpPr>
            <a:xfrm>
              <a:off x="1816845" y="1735373"/>
              <a:ext cx="8520265" cy="3922143"/>
              <a:chOff x="781421" y="740291"/>
              <a:chExt cx="8520265" cy="3922143"/>
            </a:xfrm>
          </p:grpSpPr>
          <p:cxnSp>
            <p:nvCxnSpPr>
              <p:cNvPr id="85" name="Straight Connector 84"/>
              <p:cNvCxnSpPr/>
              <p:nvPr/>
            </p:nvCxnSpPr>
            <p:spPr>
              <a:xfrm flipV="1">
                <a:off x="6024232" y="3948675"/>
                <a:ext cx="2800809" cy="1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" name="Rectangle 3"/>
              <p:cNvSpPr/>
              <p:nvPr/>
            </p:nvSpPr>
            <p:spPr>
              <a:xfrm>
                <a:off x="1313641" y="1576871"/>
                <a:ext cx="1708350" cy="403412"/>
              </a:xfrm>
              <a:prstGeom prst="rect">
                <a:avLst/>
              </a:prstGeom>
              <a:solidFill>
                <a:schemeClr val="bg1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" name="TextBox 4"/>
              <p:cNvSpPr txBox="1"/>
              <p:nvPr/>
            </p:nvSpPr>
            <p:spPr>
              <a:xfrm>
                <a:off x="902494" y="740291"/>
                <a:ext cx="170514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MAT1-1;MAT1-2</a:t>
                </a:r>
                <a:endParaRPr lang="en-US" dirty="0"/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1056298" y="1634983"/>
                <a:ext cx="30168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5’</a:t>
                </a:r>
                <a:endParaRPr lang="en-US" sz="1200" dirty="0"/>
              </a:p>
            </p:txBody>
          </p:sp>
          <p:sp>
            <p:nvSpPr>
              <p:cNvPr id="8" name="Rectangle 7"/>
              <p:cNvSpPr/>
              <p:nvPr/>
            </p:nvSpPr>
            <p:spPr>
              <a:xfrm>
                <a:off x="4754978" y="1576871"/>
                <a:ext cx="335139" cy="403412"/>
              </a:xfrm>
              <a:prstGeom prst="rect">
                <a:avLst/>
              </a:prstGeom>
              <a:solidFill>
                <a:schemeClr val="bg1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5074627" y="1652570"/>
                <a:ext cx="30168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3’</a:t>
                </a:r>
                <a:endParaRPr lang="en-US" sz="1200" dirty="0"/>
              </a:p>
            </p:txBody>
          </p:sp>
          <p:cxnSp>
            <p:nvCxnSpPr>
              <p:cNvPr id="17" name="Straight Connector 16"/>
              <p:cNvCxnSpPr/>
              <p:nvPr/>
            </p:nvCxnSpPr>
            <p:spPr>
              <a:xfrm flipV="1">
                <a:off x="3021991" y="1766085"/>
                <a:ext cx="1730297" cy="24985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Rectangle 18"/>
              <p:cNvSpPr/>
              <p:nvPr/>
            </p:nvSpPr>
            <p:spPr>
              <a:xfrm>
                <a:off x="1656613" y="1576871"/>
                <a:ext cx="546097" cy="403412"/>
              </a:xfrm>
              <a:prstGeom prst="rect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20" name="Rectangle 19"/>
              <p:cNvSpPr/>
              <p:nvPr/>
            </p:nvSpPr>
            <p:spPr>
              <a:xfrm>
                <a:off x="4982565" y="1576871"/>
                <a:ext cx="49821" cy="403412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1421347" y="1950493"/>
                <a:ext cx="101662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 smtClean="0"/>
                  <a:t>11049-10781</a:t>
                </a:r>
                <a:endParaRPr lang="en-US" sz="1200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781421" y="1950493"/>
                <a:ext cx="6158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11,300</a:t>
                </a:r>
                <a:endParaRPr lang="en-US" sz="1200" dirty="0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19563807">
                <a:off x="1656462" y="1127120"/>
                <a:ext cx="101662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11059-10996</a:t>
                </a:r>
                <a:endParaRPr lang="en-US" sz="1200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4959106" y="1943819"/>
                <a:ext cx="49885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6512</a:t>
                </a:r>
                <a:endParaRPr lang="en-US" sz="1200" dirty="0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 rot="19456283">
                <a:off x="4838101" y="1169890"/>
                <a:ext cx="85953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6606-6553</a:t>
                </a:r>
                <a:endParaRPr lang="en-US" sz="1200" dirty="0"/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 rot="19456283">
                <a:off x="4587325" y="1159290"/>
                <a:ext cx="89479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6810- 6696</a:t>
                </a:r>
                <a:endParaRPr lang="en-US" sz="1200" dirty="0"/>
              </a:p>
            </p:txBody>
          </p:sp>
          <p:sp>
            <p:nvSpPr>
              <p:cNvPr id="32" name="Rectangle 31"/>
              <p:cNvSpPr/>
              <p:nvPr/>
            </p:nvSpPr>
            <p:spPr>
              <a:xfrm>
                <a:off x="4752288" y="1576871"/>
                <a:ext cx="169065" cy="403412"/>
              </a:xfrm>
              <a:prstGeom prst="rect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33" name="Rectangle 32"/>
              <p:cNvSpPr/>
              <p:nvPr/>
            </p:nvSpPr>
            <p:spPr>
              <a:xfrm>
                <a:off x="2765405" y="1576871"/>
                <a:ext cx="163057" cy="403412"/>
              </a:xfrm>
              <a:prstGeom prst="rect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34" name="Rectangle 33"/>
              <p:cNvSpPr/>
              <p:nvPr/>
            </p:nvSpPr>
            <p:spPr>
              <a:xfrm>
                <a:off x="1816557" y="1576871"/>
                <a:ext cx="54892" cy="403412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 rot="19456283">
                <a:off x="2628369" y="1114593"/>
                <a:ext cx="10518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10398- 10284</a:t>
                </a:r>
                <a:endParaRPr lang="en-US" sz="1200" dirty="0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1713354" y="2863327"/>
                <a:ext cx="82586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(1,140 </a:t>
                </a:r>
                <a:r>
                  <a:rPr lang="en-US" sz="1200" dirty="0" err="1" smtClean="0"/>
                  <a:t>bp</a:t>
                </a:r>
                <a:r>
                  <a:rPr lang="en-US" sz="1200" dirty="0" smtClean="0"/>
                  <a:t>)</a:t>
                </a:r>
                <a:endParaRPr lang="en-US" sz="1200" dirty="0"/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4606677" y="2863327"/>
                <a:ext cx="78493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(229 </a:t>
                </a:r>
                <a:r>
                  <a:rPr lang="en-US" sz="1200" dirty="0" err="1" smtClean="0"/>
                  <a:t>bp</a:t>
                </a:r>
                <a:r>
                  <a:rPr lang="en-US" sz="1200" dirty="0" smtClean="0"/>
                  <a:t>)</a:t>
                </a:r>
                <a:endParaRPr lang="en-US" sz="1200" dirty="0"/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3575518" y="2185207"/>
                <a:ext cx="85439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/>
                  <a:t>(3,349 </a:t>
                </a:r>
                <a:r>
                  <a:rPr lang="en-US" sz="1200" dirty="0" err="1" smtClean="0"/>
                  <a:t>bp</a:t>
                </a:r>
                <a:r>
                  <a:rPr lang="en-US" sz="1200" dirty="0" smtClean="0"/>
                  <a:t>)</a:t>
                </a:r>
                <a:endParaRPr lang="en-US" sz="1200" dirty="0"/>
              </a:p>
            </p:txBody>
          </p:sp>
          <p:sp>
            <p:nvSpPr>
              <p:cNvPr id="49" name="Rectangle 48"/>
              <p:cNvSpPr/>
              <p:nvPr/>
            </p:nvSpPr>
            <p:spPr>
              <a:xfrm>
                <a:off x="3202064" y="1576871"/>
                <a:ext cx="656129" cy="403412"/>
              </a:xfrm>
              <a:prstGeom prst="rect">
                <a:avLst/>
              </a:prstGeom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1578824" y="2494258"/>
                <a:ext cx="1100045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 smtClean="0"/>
                  <a:t>MAT1-1-1 </a:t>
                </a:r>
              </a:p>
              <a:p>
                <a:pPr algn="ctr"/>
                <a:r>
                  <a:rPr lang="en-US" sz="1200" dirty="0" smtClean="0"/>
                  <a:t>large fragment</a:t>
                </a:r>
                <a:endParaRPr lang="en-US" sz="1200" dirty="0"/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3892339" y="2494258"/>
                <a:ext cx="211166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/>
                  <a:t>MAT1-1-1 </a:t>
                </a:r>
              </a:p>
              <a:p>
                <a:pPr algn="ctr"/>
                <a:r>
                  <a:rPr lang="en-US" sz="1200" dirty="0" smtClean="0"/>
                  <a:t>small fragment</a:t>
                </a:r>
                <a:endParaRPr lang="en-US" sz="1200" dirty="0"/>
              </a:p>
            </p:txBody>
          </p:sp>
          <p:cxnSp>
            <p:nvCxnSpPr>
              <p:cNvPr id="54" name="Straight Connector 53"/>
              <p:cNvCxnSpPr/>
              <p:nvPr/>
            </p:nvCxnSpPr>
            <p:spPr>
              <a:xfrm>
                <a:off x="3060922" y="2231444"/>
                <a:ext cx="1728792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Straight Connector 43"/>
              <p:cNvCxnSpPr/>
              <p:nvPr/>
            </p:nvCxnSpPr>
            <p:spPr>
              <a:xfrm flipH="1">
                <a:off x="4377629" y="1674111"/>
                <a:ext cx="191588" cy="24362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/>
              <p:cNvCxnSpPr/>
              <p:nvPr/>
            </p:nvCxnSpPr>
            <p:spPr>
              <a:xfrm flipH="1">
                <a:off x="4442835" y="1674111"/>
                <a:ext cx="191588" cy="24362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Right Arrow 40"/>
              <p:cNvSpPr/>
              <p:nvPr/>
            </p:nvSpPr>
            <p:spPr>
              <a:xfrm>
                <a:off x="5587399" y="1718333"/>
                <a:ext cx="442495" cy="119988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2" name="Rectangle 61"/>
              <p:cNvSpPr/>
              <p:nvPr/>
            </p:nvSpPr>
            <p:spPr>
              <a:xfrm>
                <a:off x="2934755" y="1576871"/>
                <a:ext cx="86073" cy="403412"/>
              </a:xfrm>
              <a:prstGeom prst="rect">
                <a:avLst/>
              </a:prstGeom>
              <a:solidFill>
                <a:srgbClr val="339933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grpSp>
            <p:nvGrpSpPr>
              <p:cNvPr id="2" name="Group 1"/>
              <p:cNvGrpSpPr/>
              <p:nvPr/>
            </p:nvGrpSpPr>
            <p:grpSpPr>
              <a:xfrm>
                <a:off x="6152713" y="3718937"/>
                <a:ext cx="2467898" cy="417324"/>
                <a:chOff x="6193472" y="1562959"/>
                <a:chExt cx="2467898" cy="417324"/>
              </a:xfrm>
            </p:grpSpPr>
            <p:sp>
              <p:nvSpPr>
                <p:cNvPr id="56" name="Rectangle 55"/>
                <p:cNvSpPr/>
                <p:nvPr/>
              </p:nvSpPr>
              <p:spPr>
                <a:xfrm>
                  <a:off x="6537399" y="1576871"/>
                  <a:ext cx="1641462" cy="403412"/>
                </a:xfrm>
                <a:prstGeom prst="rect">
                  <a:avLst/>
                </a:prstGeom>
                <a:solidFill>
                  <a:schemeClr val="bg1"/>
                </a:solidFill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7" name="TextBox 56"/>
                <p:cNvSpPr txBox="1"/>
                <p:nvPr/>
              </p:nvSpPr>
              <p:spPr>
                <a:xfrm>
                  <a:off x="6193472" y="1562959"/>
                  <a:ext cx="30168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/>
                    <a:t>5’</a:t>
                  </a:r>
                  <a:endParaRPr lang="en-US" sz="1200" dirty="0"/>
                </a:p>
              </p:txBody>
            </p:sp>
            <p:sp>
              <p:nvSpPr>
                <p:cNvPr id="58" name="TextBox 57"/>
                <p:cNvSpPr txBox="1"/>
                <p:nvPr/>
              </p:nvSpPr>
              <p:spPr>
                <a:xfrm>
                  <a:off x="8359684" y="1562959"/>
                  <a:ext cx="30168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/>
                    <a:t>3’</a:t>
                  </a:r>
                  <a:endParaRPr lang="en-US" sz="1200" dirty="0"/>
                </a:p>
              </p:txBody>
            </p:sp>
            <p:sp>
              <p:nvSpPr>
                <p:cNvPr id="59" name="Rectangle 58"/>
                <p:cNvSpPr/>
                <p:nvPr/>
              </p:nvSpPr>
              <p:spPr>
                <a:xfrm>
                  <a:off x="6851289" y="1576871"/>
                  <a:ext cx="546097" cy="403412"/>
                </a:xfrm>
                <a:prstGeom prst="rect">
                  <a:avLst/>
                </a:prstGeom>
                <a:solidFill>
                  <a:schemeClr val="tx2">
                    <a:lumMod val="60000"/>
                    <a:lumOff val="40000"/>
                  </a:schemeClr>
                </a:solidFill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61" name="Rectangle 60"/>
                <p:cNvSpPr/>
                <p:nvPr/>
              </p:nvSpPr>
              <p:spPr>
                <a:xfrm>
                  <a:off x="7011233" y="1576871"/>
                  <a:ext cx="54892" cy="403412"/>
                </a:xfrm>
                <a:prstGeom prst="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grpSp>
            <p:nvGrpSpPr>
              <p:cNvPr id="13" name="Group 12"/>
              <p:cNvGrpSpPr/>
              <p:nvPr/>
            </p:nvGrpSpPr>
            <p:grpSpPr>
              <a:xfrm>
                <a:off x="2238716" y="3427194"/>
                <a:ext cx="936193" cy="403412"/>
                <a:chOff x="1421349" y="3908259"/>
                <a:chExt cx="936193" cy="403412"/>
              </a:xfrm>
            </p:grpSpPr>
            <p:sp>
              <p:nvSpPr>
                <p:cNvPr id="64" name="Rectangle 63"/>
                <p:cNvSpPr/>
                <p:nvPr/>
              </p:nvSpPr>
              <p:spPr>
                <a:xfrm>
                  <a:off x="1421349" y="3908259"/>
                  <a:ext cx="69264" cy="403412"/>
                </a:xfrm>
                <a:prstGeom prst="rect">
                  <a:avLst/>
                </a:prstGeom>
                <a:solidFill>
                  <a:schemeClr val="tx2">
                    <a:lumMod val="60000"/>
                    <a:lumOff val="40000"/>
                  </a:schemeClr>
                </a:solidFill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65" name="TextBox 64"/>
                <p:cNvSpPr txBox="1"/>
                <p:nvPr/>
              </p:nvSpPr>
              <p:spPr>
                <a:xfrm>
                  <a:off x="1454538" y="3971465"/>
                  <a:ext cx="90300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a</a:t>
                  </a:r>
                  <a:r>
                    <a:rPr lang="en-US" sz="1200" dirty="0" smtClean="0"/>
                    <a:t>lpha 1 box</a:t>
                  </a:r>
                  <a:endParaRPr lang="en-US" sz="1200" dirty="0"/>
                </a:p>
              </p:txBody>
            </p:sp>
          </p:grpSp>
          <p:grpSp>
            <p:nvGrpSpPr>
              <p:cNvPr id="14" name="Group 13"/>
              <p:cNvGrpSpPr/>
              <p:nvPr/>
            </p:nvGrpSpPr>
            <p:grpSpPr>
              <a:xfrm>
                <a:off x="1920091" y="3960876"/>
                <a:ext cx="2206200" cy="461665"/>
                <a:chOff x="2252426" y="3905428"/>
                <a:chExt cx="2206200" cy="461665"/>
              </a:xfrm>
            </p:grpSpPr>
            <p:sp>
              <p:nvSpPr>
                <p:cNvPr id="68" name="Rectangle 67"/>
                <p:cNvSpPr/>
                <p:nvPr/>
              </p:nvSpPr>
              <p:spPr>
                <a:xfrm>
                  <a:off x="2252426" y="3908259"/>
                  <a:ext cx="69264" cy="403412"/>
                </a:xfrm>
                <a:prstGeom prst="rect">
                  <a:avLst/>
                </a:prstGeom>
                <a:solidFill>
                  <a:srgbClr val="00B050"/>
                </a:solidFill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69" name="TextBox 68"/>
                <p:cNvSpPr txBox="1"/>
                <p:nvPr/>
              </p:nvSpPr>
              <p:spPr>
                <a:xfrm>
                  <a:off x="2285339" y="3905428"/>
                  <a:ext cx="2173287" cy="4616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/>
                    <a:t>eliminated from large fragment </a:t>
                  </a:r>
                </a:p>
                <a:p>
                  <a:r>
                    <a:rPr lang="en-US" sz="1200" dirty="0" smtClean="0"/>
                    <a:t>upon DR recombination</a:t>
                  </a:r>
                  <a:endParaRPr lang="en-US" sz="1200" dirty="0"/>
                </a:p>
              </p:txBody>
            </p:sp>
          </p:grpSp>
          <p:grpSp>
            <p:nvGrpSpPr>
              <p:cNvPr id="12" name="Group 11"/>
              <p:cNvGrpSpPr/>
              <p:nvPr/>
            </p:nvGrpSpPr>
            <p:grpSpPr>
              <a:xfrm>
                <a:off x="3820146" y="3427194"/>
                <a:ext cx="411082" cy="403412"/>
                <a:chOff x="2242449" y="3402762"/>
                <a:chExt cx="411082" cy="403412"/>
              </a:xfrm>
            </p:grpSpPr>
            <p:sp>
              <p:nvSpPr>
                <p:cNvPr id="67" name="TextBox 66"/>
                <p:cNvSpPr txBox="1"/>
                <p:nvPr/>
              </p:nvSpPr>
              <p:spPr>
                <a:xfrm>
                  <a:off x="2290931" y="3465969"/>
                  <a:ext cx="36260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/>
                    <a:t>DR</a:t>
                  </a:r>
                  <a:endParaRPr lang="en-US" sz="1200" dirty="0"/>
                </a:p>
              </p:txBody>
            </p:sp>
            <p:sp>
              <p:nvSpPr>
                <p:cNvPr id="70" name="Rectangle 69"/>
                <p:cNvSpPr/>
                <p:nvPr/>
              </p:nvSpPr>
              <p:spPr>
                <a:xfrm>
                  <a:off x="2242449" y="3402762"/>
                  <a:ext cx="69264" cy="403412"/>
                </a:xfrm>
                <a:prstGeom prst="rect">
                  <a:avLst/>
                </a:prstGeom>
                <a:solidFill>
                  <a:srgbClr val="FF0000"/>
                </a:solidFill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grpSp>
            <p:nvGrpSpPr>
              <p:cNvPr id="3" name="Group 2"/>
              <p:cNvGrpSpPr/>
              <p:nvPr/>
            </p:nvGrpSpPr>
            <p:grpSpPr>
              <a:xfrm>
                <a:off x="3197140" y="3427194"/>
                <a:ext cx="600775" cy="403412"/>
                <a:chOff x="1421349" y="3402762"/>
                <a:chExt cx="600775" cy="403412"/>
              </a:xfrm>
            </p:grpSpPr>
            <p:sp>
              <p:nvSpPr>
                <p:cNvPr id="63" name="TextBox 62"/>
                <p:cNvSpPr txBox="1"/>
                <p:nvPr/>
              </p:nvSpPr>
              <p:spPr>
                <a:xfrm>
                  <a:off x="1459854" y="3465969"/>
                  <a:ext cx="56227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/>
                    <a:t>intron</a:t>
                  </a:r>
                  <a:endParaRPr lang="en-US" sz="1200" dirty="0"/>
                </a:p>
              </p:txBody>
            </p:sp>
            <p:sp>
              <p:nvSpPr>
                <p:cNvPr id="71" name="Rectangle 70"/>
                <p:cNvSpPr/>
                <p:nvPr/>
              </p:nvSpPr>
              <p:spPr>
                <a:xfrm>
                  <a:off x="1421349" y="3402762"/>
                  <a:ext cx="69264" cy="403412"/>
                </a:xfrm>
                <a:prstGeom prst="rect">
                  <a:avLst/>
                </a:prstGeom>
                <a:solidFill>
                  <a:srgbClr val="FFC000"/>
                </a:solidFill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cxnSp>
            <p:nvCxnSpPr>
              <p:cNvPr id="72" name="Straight Connector 71"/>
              <p:cNvCxnSpPr/>
              <p:nvPr/>
            </p:nvCxnSpPr>
            <p:spPr>
              <a:xfrm flipH="1">
                <a:off x="4355911" y="2075654"/>
                <a:ext cx="191588" cy="24362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Connector 72"/>
              <p:cNvCxnSpPr/>
              <p:nvPr/>
            </p:nvCxnSpPr>
            <p:spPr>
              <a:xfrm flipH="1">
                <a:off x="4412325" y="2075654"/>
                <a:ext cx="191588" cy="24362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4" name="Rectangle 73"/>
              <p:cNvSpPr/>
              <p:nvPr/>
            </p:nvSpPr>
            <p:spPr>
              <a:xfrm>
                <a:off x="6442827" y="1596362"/>
                <a:ext cx="1708350" cy="403412"/>
              </a:xfrm>
              <a:prstGeom prst="rect">
                <a:avLst/>
              </a:prstGeom>
              <a:solidFill>
                <a:schemeClr val="bg1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9" name="Rectangle 78"/>
              <p:cNvSpPr/>
              <p:nvPr/>
            </p:nvSpPr>
            <p:spPr>
              <a:xfrm>
                <a:off x="6785799" y="1596362"/>
                <a:ext cx="546097" cy="403412"/>
              </a:xfrm>
              <a:prstGeom prst="rect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90" name="Rectangle 89"/>
              <p:cNvSpPr/>
              <p:nvPr/>
            </p:nvSpPr>
            <p:spPr>
              <a:xfrm>
                <a:off x="6945743" y="1596362"/>
                <a:ext cx="54892" cy="403412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99" name="Right Arrow 98"/>
              <p:cNvSpPr/>
              <p:nvPr/>
            </p:nvSpPr>
            <p:spPr>
              <a:xfrm rot="5400000">
                <a:off x="7772464" y="3343202"/>
                <a:ext cx="442495" cy="119988"/>
              </a:xfrm>
              <a:prstGeom prst="rightArrow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00" name="Rectangle 99"/>
              <p:cNvSpPr/>
              <p:nvPr/>
            </p:nvSpPr>
            <p:spPr>
              <a:xfrm>
                <a:off x="8063941" y="1596362"/>
                <a:ext cx="86073" cy="403412"/>
              </a:xfrm>
              <a:prstGeom prst="rect">
                <a:avLst/>
              </a:prstGeom>
              <a:solidFill>
                <a:srgbClr val="00B05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grpSp>
            <p:nvGrpSpPr>
              <p:cNvPr id="10" name="Group 9"/>
              <p:cNvGrpSpPr/>
              <p:nvPr/>
            </p:nvGrpSpPr>
            <p:grpSpPr>
              <a:xfrm>
                <a:off x="4243068" y="3427194"/>
                <a:ext cx="843295" cy="403412"/>
                <a:chOff x="3191996" y="3402762"/>
                <a:chExt cx="843295" cy="403412"/>
              </a:xfrm>
            </p:grpSpPr>
            <p:sp>
              <p:nvSpPr>
                <p:cNvPr id="50" name="TextBox 49"/>
                <p:cNvSpPr txBox="1"/>
                <p:nvPr/>
              </p:nvSpPr>
              <p:spPr>
                <a:xfrm>
                  <a:off x="3237509" y="3465969"/>
                  <a:ext cx="79778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/>
                    <a:t>MAT1-2-1</a:t>
                  </a:r>
                  <a:endParaRPr lang="en-US" sz="1200" dirty="0"/>
                </a:p>
              </p:txBody>
            </p:sp>
            <p:sp>
              <p:nvSpPr>
                <p:cNvPr id="103" name="Rectangle 102"/>
                <p:cNvSpPr/>
                <p:nvPr/>
              </p:nvSpPr>
              <p:spPr>
                <a:xfrm>
                  <a:off x="3191996" y="3402762"/>
                  <a:ext cx="69264" cy="403412"/>
                </a:xfrm>
                <a:prstGeom prst="rect">
                  <a:avLst/>
                </a:prstGeom>
                <a:pattFill prst="wdDnDiag">
                  <a:fgClr>
                    <a:schemeClr val="tx1"/>
                  </a:fgClr>
                  <a:bgClr>
                    <a:schemeClr val="bg1"/>
                  </a:bgClr>
                </a:pattFill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grpSp>
            <p:nvGrpSpPr>
              <p:cNvPr id="7" name="Group 6"/>
              <p:cNvGrpSpPr/>
              <p:nvPr/>
            </p:nvGrpSpPr>
            <p:grpSpPr>
              <a:xfrm>
                <a:off x="1384071" y="3427194"/>
                <a:ext cx="832414" cy="403412"/>
                <a:chOff x="4198998" y="3402762"/>
                <a:chExt cx="832414" cy="403412"/>
              </a:xfrm>
            </p:grpSpPr>
            <p:sp>
              <p:nvSpPr>
                <p:cNvPr id="104" name="Rectangle 103"/>
                <p:cNvSpPr/>
                <p:nvPr/>
              </p:nvSpPr>
              <p:spPr>
                <a:xfrm>
                  <a:off x="4198998" y="3402762"/>
                  <a:ext cx="69264" cy="403412"/>
                </a:xfrm>
                <a:prstGeom prst="rect">
                  <a:avLst/>
                </a:prstGeom>
                <a:solidFill>
                  <a:schemeClr val="bg1"/>
                </a:solidFill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05" name="TextBox 104"/>
                <p:cNvSpPr txBox="1"/>
                <p:nvPr/>
              </p:nvSpPr>
              <p:spPr>
                <a:xfrm>
                  <a:off x="4233630" y="3465969"/>
                  <a:ext cx="79778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/>
                    <a:t>MAT1-1-1</a:t>
                  </a:r>
                  <a:endParaRPr lang="en-US" sz="1200" dirty="0"/>
                </a:p>
              </p:txBody>
            </p:sp>
          </p:grpSp>
          <p:cxnSp>
            <p:nvCxnSpPr>
              <p:cNvPr id="106" name="Straight Connector 105"/>
              <p:cNvCxnSpPr/>
              <p:nvPr/>
            </p:nvCxnSpPr>
            <p:spPr>
              <a:xfrm flipV="1">
                <a:off x="8225634" y="2760267"/>
                <a:ext cx="526518" cy="1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" name="TextBox 74"/>
              <p:cNvSpPr txBox="1"/>
              <p:nvPr/>
            </p:nvSpPr>
            <p:spPr>
              <a:xfrm>
                <a:off x="3111826" y="2494258"/>
                <a:ext cx="79778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MAT1-2-1</a:t>
                </a:r>
                <a:endParaRPr lang="en-US" sz="1200" dirty="0"/>
              </a:p>
            </p:txBody>
          </p:sp>
          <p:sp>
            <p:nvSpPr>
              <p:cNvPr id="77" name="Rectangle 76"/>
              <p:cNvSpPr/>
              <p:nvPr/>
            </p:nvSpPr>
            <p:spPr>
              <a:xfrm>
                <a:off x="7894820" y="1596362"/>
                <a:ext cx="169065" cy="403412"/>
              </a:xfrm>
              <a:prstGeom prst="rect">
                <a:avLst/>
              </a:prstGeom>
              <a:solidFill>
                <a:srgbClr val="FF0000"/>
              </a:solid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9" name="Freeform 8"/>
              <p:cNvSpPr/>
              <p:nvPr/>
            </p:nvSpPr>
            <p:spPr>
              <a:xfrm>
                <a:off x="7194883" y="1730723"/>
                <a:ext cx="1274885" cy="1046529"/>
              </a:xfrm>
              <a:custGeom>
                <a:avLst/>
                <a:gdLst>
                  <a:gd name="connsiteX0" fmla="*/ 958362 w 1274885"/>
                  <a:gd name="connsiteY0" fmla="*/ 9037 h 1046529"/>
                  <a:gd name="connsiteX1" fmla="*/ 1213339 w 1274885"/>
                  <a:gd name="connsiteY1" fmla="*/ 9037 h 1046529"/>
                  <a:gd name="connsiteX2" fmla="*/ 1239716 w 1274885"/>
                  <a:gd name="connsiteY2" fmla="*/ 35414 h 1046529"/>
                  <a:gd name="connsiteX3" fmla="*/ 1248508 w 1274885"/>
                  <a:gd name="connsiteY3" fmla="*/ 70583 h 1046529"/>
                  <a:gd name="connsiteX4" fmla="*/ 1266093 w 1274885"/>
                  <a:gd name="connsiteY4" fmla="*/ 96960 h 1046529"/>
                  <a:gd name="connsiteX5" fmla="*/ 1274885 w 1274885"/>
                  <a:gd name="connsiteY5" fmla="*/ 123337 h 1046529"/>
                  <a:gd name="connsiteX6" fmla="*/ 1266093 w 1274885"/>
                  <a:gd name="connsiteY6" fmla="*/ 228844 h 1046529"/>
                  <a:gd name="connsiteX7" fmla="*/ 1195754 w 1274885"/>
                  <a:gd name="connsiteY7" fmla="*/ 290391 h 1046529"/>
                  <a:gd name="connsiteX8" fmla="*/ 1169377 w 1274885"/>
                  <a:gd name="connsiteY8" fmla="*/ 307975 h 1046529"/>
                  <a:gd name="connsiteX9" fmla="*/ 1143000 w 1274885"/>
                  <a:gd name="connsiteY9" fmla="*/ 325560 h 1046529"/>
                  <a:gd name="connsiteX10" fmla="*/ 1116623 w 1274885"/>
                  <a:gd name="connsiteY10" fmla="*/ 334352 h 1046529"/>
                  <a:gd name="connsiteX11" fmla="*/ 993531 w 1274885"/>
                  <a:gd name="connsiteY11" fmla="*/ 404691 h 1046529"/>
                  <a:gd name="connsiteX12" fmla="*/ 958362 w 1274885"/>
                  <a:gd name="connsiteY12" fmla="*/ 422275 h 1046529"/>
                  <a:gd name="connsiteX13" fmla="*/ 931985 w 1274885"/>
                  <a:gd name="connsiteY13" fmla="*/ 431068 h 1046529"/>
                  <a:gd name="connsiteX14" fmla="*/ 905608 w 1274885"/>
                  <a:gd name="connsiteY14" fmla="*/ 448652 h 1046529"/>
                  <a:gd name="connsiteX15" fmla="*/ 844062 w 1274885"/>
                  <a:gd name="connsiteY15" fmla="*/ 466237 h 1046529"/>
                  <a:gd name="connsiteX16" fmla="*/ 720970 w 1274885"/>
                  <a:gd name="connsiteY16" fmla="*/ 510198 h 1046529"/>
                  <a:gd name="connsiteX17" fmla="*/ 650631 w 1274885"/>
                  <a:gd name="connsiteY17" fmla="*/ 527783 h 1046529"/>
                  <a:gd name="connsiteX18" fmla="*/ 624254 w 1274885"/>
                  <a:gd name="connsiteY18" fmla="*/ 536575 h 1046529"/>
                  <a:gd name="connsiteX19" fmla="*/ 589085 w 1274885"/>
                  <a:gd name="connsiteY19" fmla="*/ 545368 h 1046529"/>
                  <a:gd name="connsiteX20" fmla="*/ 483577 w 1274885"/>
                  <a:gd name="connsiteY20" fmla="*/ 562952 h 1046529"/>
                  <a:gd name="connsiteX21" fmla="*/ 448408 w 1274885"/>
                  <a:gd name="connsiteY21" fmla="*/ 571744 h 1046529"/>
                  <a:gd name="connsiteX22" fmla="*/ 422031 w 1274885"/>
                  <a:gd name="connsiteY22" fmla="*/ 580537 h 1046529"/>
                  <a:gd name="connsiteX23" fmla="*/ 351693 w 1274885"/>
                  <a:gd name="connsiteY23" fmla="*/ 598121 h 1046529"/>
                  <a:gd name="connsiteX24" fmla="*/ 325316 w 1274885"/>
                  <a:gd name="connsiteY24" fmla="*/ 606914 h 1046529"/>
                  <a:gd name="connsiteX25" fmla="*/ 298939 w 1274885"/>
                  <a:gd name="connsiteY25" fmla="*/ 624498 h 1046529"/>
                  <a:gd name="connsiteX26" fmla="*/ 219808 w 1274885"/>
                  <a:gd name="connsiteY26" fmla="*/ 650875 h 1046529"/>
                  <a:gd name="connsiteX27" fmla="*/ 193431 w 1274885"/>
                  <a:gd name="connsiteY27" fmla="*/ 659668 h 1046529"/>
                  <a:gd name="connsiteX28" fmla="*/ 167054 w 1274885"/>
                  <a:gd name="connsiteY28" fmla="*/ 686044 h 1046529"/>
                  <a:gd name="connsiteX29" fmla="*/ 105508 w 1274885"/>
                  <a:gd name="connsiteY29" fmla="*/ 703629 h 1046529"/>
                  <a:gd name="connsiteX30" fmla="*/ 52754 w 1274885"/>
                  <a:gd name="connsiteY30" fmla="*/ 747591 h 1046529"/>
                  <a:gd name="connsiteX31" fmla="*/ 43962 w 1274885"/>
                  <a:gd name="connsiteY31" fmla="*/ 773968 h 1046529"/>
                  <a:gd name="connsiteX32" fmla="*/ 26377 w 1274885"/>
                  <a:gd name="connsiteY32" fmla="*/ 800344 h 1046529"/>
                  <a:gd name="connsiteX33" fmla="*/ 0 w 1274885"/>
                  <a:gd name="connsiteY33" fmla="*/ 861891 h 1046529"/>
                  <a:gd name="connsiteX34" fmla="*/ 8793 w 1274885"/>
                  <a:gd name="connsiteY34" fmla="*/ 949814 h 1046529"/>
                  <a:gd name="connsiteX35" fmla="*/ 52754 w 1274885"/>
                  <a:gd name="connsiteY35" fmla="*/ 1002568 h 1046529"/>
                  <a:gd name="connsiteX36" fmla="*/ 79131 w 1274885"/>
                  <a:gd name="connsiteY36" fmla="*/ 1011360 h 1046529"/>
                  <a:gd name="connsiteX37" fmla="*/ 114300 w 1274885"/>
                  <a:gd name="connsiteY37" fmla="*/ 1028944 h 1046529"/>
                  <a:gd name="connsiteX38" fmla="*/ 167054 w 1274885"/>
                  <a:gd name="connsiteY38" fmla="*/ 1046529 h 1046529"/>
                  <a:gd name="connsiteX39" fmla="*/ 615462 w 1274885"/>
                  <a:gd name="connsiteY39" fmla="*/ 1037737 h 1046529"/>
                  <a:gd name="connsiteX40" fmla="*/ 703385 w 1274885"/>
                  <a:gd name="connsiteY40" fmla="*/ 1028944 h 104652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</a:cxnLst>
                <a:rect l="l" t="t" r="r" b="b"/>
                <a:pathLst>
                  <a:path w="1274885" h="1046529">
                    <a:moveTo>
                      <a:pt x="958362" y="9037"/>
                    </a:moveTo>
                    <a:cubicBezTo>
                      <a:pt x="1027445" y="4719"/>
                      <a:pt x="1141440" y="-8938"/>
                      <a:pt x="1213339" y="9037"/>
                    </a:cubicBezTo>
                    <a:cubicBezTo>
                      <a:pt x="1225402" y="12053"/>
                      <a:pt x="1230924" y="26622"/>
                      <a:pt x="1239716" y="35414"/>
                    </a:cubicBezTo>
                    <a:cubicBezTo>
                      <a:pt x="1242647" y="47137"/>
                      <a:pt x="1243748" y="59476"/>
                      <a:pt x="1248508" y="70583"/>
                    </a:cubicBezTo>
                    <a:cubicBezTo>
                      <a:pt x="1252671" y="80296"/>
                      <a:pt x="1261367" y="87508"/>
                      <a:pt x="1266093" y="96960"/>
                    </a:cubicBezTo>
                    <a:cubicBezTo>
                      <a:pt x="1270238" y="105249"/>
                      <a:pt x="1271954" y="114545"/>
                      <a:pt x="1274885" y="123337"/>
                    </a:cubicBezTo>
                    <a:cubicBezTo>
                      <a:pt x="1271954" y="158506"/>
                      <a:pt x="1273014" y="194238"/>
                      <a:pt x="1266093" y="228844"/>
                    </a:cubicBezTo>
                    <a:cubicBezTo>
                      <a:pt x="1260457" y="257024"/>
                      <a:pt x="1209956" y="280923"/>
                      <a:pt x="1195754" y="290391"/>
                    </a:cubicBezTo>
                    <a:lnTo>
                      <a:pt x="1169377" y="307975"/>
                    </a:lnTo>
                    <a:cubicBezTo>
                      <a:pt x="1160585" y="313837"/>
                      <a:pt x="1153025" y="322218"/>
                      <a:pt x="1143000" y="325560"/>
                    </a:cubicBezTo>
                    <a:lnTo>
                      <a:pt x="1116623" y="334352"/>
                    </a:lnTo>
                    <a:cubicBezTo>
                      <a:pt x="1042062" y="384060"/>
                      <a:pt x="1082769" y="360072"/>
                      <a:pt x="993531" y="404691"/>
                    </a:cubicBezTo>
                    <a:cubicBezTo>
                      <a:pt x="981808" y="410552"/>
                      <a:pt x="970796" y="418130"/>
                      <a:pt x="958362" y="422275"/>
                    </a:cubicBezTo>
                    <a:cubicBezTo>
                      <a:pt x="949570" y="425206"/>
                      <a:pt x="940275" y="426923"/>
                      <a:pt x="931985" y="431068"/>
                    </a:cubicBezTo>
                    <a:cubicBezTo>
                      <a:pt x="922534" y="435794"/>
                      <a:pt x="915321" y="444490"/>
                      <a:pt x="905608" y="448652"/>
                    </a:cubicBezTo>
                    <a:cubicBezTo>
                      <a:pt x="788098" y="499012"/>
                      <a:pt x="938161" y="423465"/>
                      <a:pt x="844062" y="466237"/>
                    </a:cubicBezTo>
                    <a:cubicBezTo>
                      <a:pt x="744157" y="511648"/>
                      <a:pt x="808843" y="495553"/>
                      <a:pt x="720970" y="510198"/>
                    </a:cubicBezTo>
                    <a:cubicBezTo>
                      <a:pt x="660685" y="530295"/>
                      <a:pt x="735496" y="506568"/>
                      <a:pt x="650631" y="527783"/>
                    </a:cubicBezTo>
                    <a:cubicBezTo>
                      <a:pt x="641640" y="530031"/>
                      <a:pt x="633165" y="534029"/>
                      <a:pt x="624254" y="536575"/>
                    </a:cubicBezTo>
                    <a:cubicBezTo>
                      <a:pt x="612635" y="539895"/>
                      <a:pt x="600808" y="542437"/>
                      <a:pt x="589085" y="545368"/>
                    </a:cubicBezTo>
                    <a:cubicBezTo>
                      <a:pt x="532144" y="526386"/>
                      <a:pt x="584062" y="537832"/>
                      <a:pt x="483577" y="562952"/>
                    </a:cubicBezTo>
                    <a:cubicBezTo>
                      <a:pt x="471854" y="565883"/>
                      <a:pt x="460027" y="568424"/>
                      <a:pt x="448408" y="571744"/>
                    </a:cubicBezTo>
                    <a:cubicBezTo>
                      <a:pt x="439497" y="574290"/>
                      <a:pt x="430972" y="578098"/>
                      <a:pt x="422031" y="580537"/>
                    </a:cubicBezTo>
                    <a:cubicBezTo>
                      <a:pt x="398715" y="586896"/>
                      <a:pt x="374620" y="590478"/>
                      <a:pt x="351693" y="598121"/>
                    </a:cubicBezTo>
                    <a:cubicBezTo>
                      <a:pt x="342901" y="601052"/>
                      <a:pt x="333606" y="602769"/>
                      <a:pt x="325316" y="606914"/>
                    </a:cubicBezTo>
                    <a:cubicBezTo>
                      <a:pt x="315865" y="611640"/>
                      <a:pt x="308595" y="620206"/>
                      <a:pt x="298939" y="624498"/>
                    </a:cubicBezTo>
                    <a:cubicBezTo>
                      <a:pt x="298924" y="624505"/>
                      <a:pt x="233004" y="646476"/>
                      <a:pt x="219808" y="650875"/>
                    </a:cubicBezTo>
                    <a:lnTo>
                      <a:pt x="193431" y="659668"/>
                    </a:lnTo>
                    <a:cubicBezTo>
                      <a:pt x="184639" y="668460"/>
                      <a:pt x="177400" y="679147"/>
                      <a:pt x="167054" y="686044"/>
                    </a:cubicBezTo>
                    <a:cubicBezTo>
                      <a:pt x="159483" y="691091"/>
                      <a:pt x="110202" y="702455"/>
                      <a:pt x="105508" y="703629"/>
                    </a:cubicBezTo>
                    <a:cubicBezTo>
                      <a:pt x="86045" y="716604"/>
                      <a:pt x="66293" y="727282"/>
                      <a:pt x="52754" y="747591"/>
                    </a:cubicBezTo>
                    <a:cubicBezTo>
                      <a:pt x="47613" y="755302"/>
                      <a:pt x="48107" y="765679"/>
                      <a:pt x="43962" y="773968"/>
                    </a:cubicBezTo>
                    <a:cubicBezTo>
                      <a:pt x="39236" y="783419"/>
                      <a:pt x="31620" y="791169"/>
                      <a:pt x="26377" y="800344"/>
                    </a:cubicBezTo>
                    <a:cubicBezTo>
                      <a:pt x="8997" y="830759"/>
                      <a:pt x="9863" y="832303"/>
                      <a:pt x="0" y="861891"/>
                    </a:cubicBezTo>
                    <a:cubicBezTo>
                      <a:pt x="2931" y="891199"/>
                      <a:pt x="2170" y="921114"/>
                      <a:pt x="8793" y="949814"/>
                    </a:cubicBezTo>
                    <a:cubicBezTo>
                      <a:pt x="11742" y="962594"/>
                      <a:pt x="44242" y="996893"/>
                      <a:pt x="52754" y="1002568"/>
                    </a:cubicBezTo>
                    <a:cubicBezTo>
                      <a:pt x="60465" y="1007709"/>
                      <a:pt x="70612" y="1007709"/>
                      <a:pt x="79131" y="1011360"/>
                    </a:cubicBezTo>
                    <a:cubicBezTo>
                      <a:pt x="91178" y="1016523"/>
                      <a:pt x="102131" y="1024076"/>
                      <a:pt x="114300" y="1028944"/>
                    </a:cubicBezTo>
                    <a:cubicBezTo>
                      <a:pt x="131510" y="1035828"/>
                      <a:pt x="167054" y="1046529"/>
                      <a:pt x="167054" y="1046529"/>
                    </a:cubicBezTo>
                    <a:lnTo>
                      <a:pt x="615462" y="1037737"/>
                    </a:lnTo>
                    <a:cubicBezTo>
                      <a:pt x="942135" y="1026070"/>
                      <a:pt x="381343" y="1028944"/>
                      <a:pt x="703385" y="1028944"/>
                    </a:cubicBezTo>
                  </a:path>
                </a:pathLst>
              </a:cu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4" name="Rectangle 93"/>
              <p:cNvSpPr/>
              <p:nvPr/>
            </p:nvSpPr>
            <p:spPr>
              <a:xfrm>
                <a:off x="8327396" y="1873948"/>
                <a:ext cx="203541" cy="403412"/>
              </a:xfrm>
              <a:prstGeom prst="rect">
                <a:avLst/>
              </a:prstGeom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grpSp>
            <p:nvGrpSpPr>
              <p:cNvPr id="29" name="Group 28"/>
              <p:cNvGrpSpPr/>
              <p:nvPr/>
            </p:nvGrpSpPr>
            <p:grpSpPr>
              <a:xfrm>
                <a:off x="7883676" y="2558561"/>
                <a:ext cx="341958" cy="403412"/>
                <a:chOff x="7883676" y="2558561"/>
                <a:chExt cx="341958" cy="403412"/>
              </a:xfrm>
            </p:grpSpPr>
            <p:sp>
              <p:nvSpPr>
                <p:cNvPr id="76" name="Rectangle 75"/>
                <p:cNvSpPr/>
                <p:nvPr/>
              </p:nvSpPr>
              <p:spPr>
                <a:xfrm>
                  <a:off x="7886366" y="2558561"/>
                  <a:ext cx="339268" cy="403412"/>
                </a:xfrm>
                <a:prstGeom prst="rect">
                  <a:avLst/>
                </a:prstGeom>
                <a:solidFill>
                  <a:schemeClr val="bg1"/>
                </a:solidFill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80" name="Rectangle 79"/>
                <p:cNvSpPr/>
                <p:nvPr/>
              </p:nvSpPr>
              <p:spPr>
                <a:xfrm>
                  <a:off x="8113953" y="2558561"/>
                  <a:ext cx="49821" cy="403412"/>
                </a:xfrm>
                <a:prstGeom prst="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88" name="Rectangle 87"/>
                <p:cNvSpPr/>
                <p:nvPr/>
              </p:nvSpPr>
              <p:spPr>
                <a:xfrm>
                  <a:off x="7883676" y="2558561"/>
                  <a:ext cx="169065" cy="403412"/>
                </a:xfrm>
                <a:prstGeom prst="rect">
                  <a:avLst/>
                </a:prstGeom>
                <a:solidFill>
                  <a:srgbClr val="FF0000"/>
                </a:solidFill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sp>
            <p:nvSpPr>
              <p:cNvPr id="15" name="Rectangle 14"/>
              <p:cNvSpPr/>
              <p:nvPr/>
            </p:nvSpPr>
            <p:spPr>
              <a:xfrm>
                <a:off x="1219782" y="3284681"/>
                <a:ext cx="3939297" cy="118517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8" name="Straight Connector 17"/>
              <p:cNvCxnSpPr/>
              <p:nvPr/>
            </p:nvCxnSpPr>
            <p:spPr>
              <a:xfrm>
                <a:off x="7906555" y="1999774"/>
                <a:ext cx="122283" cy="558787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/>
              <p:cNvCxnSpPr/>
              <p:nvPr/>
            </p:nvCxnSpPr>
            <p:spPr>
              <a:xfrm flipV="1">
                <a:off x="7915501" y="2005180"/>
                <a:ext cx="89112" cy="552287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lg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81" name="Group 80"/>
              <p:cNvGrpSpPr/>
              <p:nvPr/>
            </p:nvGrpSpPr>
            <p:grpSpPr>
              <a:xfrm>
                <a:off x="7956088" y="3732849"/>
                <a:ext cx="341958" cy="403412"/>
                <a:chOff x="7883676" y="2558561"/>
                <a:chExt cx="341958" cy="403412"/>
              </a:xfrm>
            </p:grpSpPr>
            <p:sp>
              <p:nvSpPr>
                <p:cNvPr id="82" name="Rectangle 81"/>
                <p:cNvSpPr/>
                <p:nvPr/>
              </p:nvSpPr>
              <p:spPr>
                <a:xfrm>
                  <a:off x="7886366" y="2558561"/>
                  <a:ext cx="339268" cy="403412"/>
                </a:xfrm>
                <a:prstGeom prst="rect">
                  <a:avLst/>
                </a:prstGeom>
                <a:solidFill>
                  <a:schemeClr val="bg1"/>
                </a:solidFill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83" name="Rectangle 82"/>
                <p:cNvSpPr/>
                <p:nvPr/>
              </p:nvSpPr>
              <p:spPr>
                <a:xfrm>
                  <a:off x="8113953" y="2558561"/>
                  <a:ext cx="49821" cy="403412"/>
                </a:xfrm>
                <a:prstGeom prst="rect">
                  <a:avLst/>
                </a:prstGeom>
                <a:solidFill>
                  <a:schemeClr val="accent4">
                    <a:lumMod val="60000"/>
                    <a:lumOff val="40000"/>
                  </a:schemeClr>
                </a:solidFill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84" name="Rectangle 83"/>
                <p:cNvSpPr/>
                <p:nvPr/>
              </p:nvSpPr>
              <p:spPr>
                <a:xfrm>
                  <a:off x="7883676" y="2558561"/>
                  <a:ext cx="169065" cy="403412"/>
                </a:xfrm>
                <a:prstGeom prst="rect">
                  <a:avLst/>
                </a:prstGeom>
                <a:solidFill>
                  <a:srgbClr val="FF0000"/>
                </a:solidFill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sp>
            <p:nvSpPr>
              <p:cNvPr id="87" name="TextBox 86"/>
              <p:cNvSpPr txBox="1"/>
              <p:nvPr/>
            </p:nvSpPr>
            <p:spPr>
              <a:xfrm>
                <a:off x="7034543" y="4136261"/>
                <a:ext cx="79778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/>
                  <a:t>MAT1-1-1</a:t>
                </a:r>
                <a:endParaRPr lang="en-US" sz="1200" dirty="0"/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5587399" y="4385435"/>
                <a:ext cx="37142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i</a:t>
                </a:r>
                <a:r>
                  <a:rPr lang="en-US" sz="1200" dirty="0" smtClean="0"/>
                  <a:t>ntact MAT1-1-1 after recombination in Cs23 and in Cs27</a:t>
                </a:r>
                <a:endParaRPr lang="en-US" sz="1200" dirty="0"/>
              </a:p>
            </p:txBody>
          </p:sp>
        </p:grpSp>
        <p:sp>
          <p:nvSpPr>
            <p:cNvPr id="86" name="TextBox 85"/>
            <p:cNvSpPr txBox="1"/>
            <p:nvPr/>
          </p:nvSpPr>
          <p:spPr>
            <a:xfrm rot="19456283">
              <a:off x="3862987" y="2127560"/>
              <a:ext cx="10518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10283- 10157</a:t>
              </a:r>
              <a:endParaRPr 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30015665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5</TotalTime>
  <Words>63</Words>
  <Application>Microsoft Office PowerPoint</Application>
  <PresentationFormat>Widescreen</PresentationFormat>
  <Paragraphs>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Cornell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ara Gillian Turgeon</dc:creator>
  <cp:lastModifiedBy>Barbara Gillian Turgeon</cp:lastModifiedBy>
  <cp:revision>34</cp:revision>
  <dcterms:created xsi:type="dcterms:W3CDTF">2017-04-11T23:17:18Z</dcterms:created>
  <dcterms:modified xsi:type="dcterms:W3CDTF">2017-08-06T12:59:04Z</dcterms:modified>
</cp:coreProperties>
</file>